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735763" cy="98679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65B5A4-D1AF-4AC4-B033-BF890D06E35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9DA692-E808-4C9B-8217-8407B118625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2248CC-E491-4A06-B938-C46DC81360A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48ACD1-6338-418C-9D81-2D9ECF69B4D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EC757A-2615-4245-99BA-52DCE529CB8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02EBD9-310E-415E-80E5-6BADB2DFFAE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05FB4F-BDAE-4C72-A63F-43C7E5DC75E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6A74AB-E61E-4FD6-9435-3483B257B64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E2CD58-F90C-4017-8F92-3EC2ED70725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8B6E9E-0DD1-46F7-84FD-42705F2310E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2D0730-52D5-42E1-B57C-2D2506BFEBB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62DC26-ABA5-483D-A24C-DDC6D20C23C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1D52510-A82D-4E59-BF67-5E86D5A209A5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1"/>
          <p:cNvSpPr/>
          <p:nvPr/>
        </p:nvSpPr>
        <p:spPr>
          <a:xfrm>
            <a:off x="115920" y="31680"/>
            <a:ext cx="662616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. 1 – Mean change (95% confidence interval) in absolute bone mineral density at 1 and 2 yr from baseline by treatment arms. (a) All patients; (b) patients still on allocated treatment only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TextBox 2"/>
          <p:cNvSpPr/>
          <p:nvPr/>
        </p:nvSpPr>
        <p:spPr>
          <a:xfrm>
            <a:off x="318960" y="4846680"/>
            <a:ext cx="630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  <a:ea typeface="Arial"/>
              </a:rPr>
              <a:t>(b)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TextBox 7"/>
          <p:cNvSpPr/>
          <p:nvPr/>
        </p:nvSpPr>
        <p:spPr>
          <a:xfrm>
            <a:off x="3701880" y="8588520"/>
            <a:ext cx="2187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GB" sz="1800" spc="-1" strike="noStrike">
                <a:solidFill>
                  <a:srgbClr val="000000"/>
                </a:solidFill>
                <a:latin typeface="Arial"/>
                <a:ea typeface="Arial"/>
              </a:rPr>
              <a:t>Oestradiol patche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Oval 358"/>
          <p:cNvSpPr/>
          <p:nvPr/>
        </p:nvSpPr>
        <p:spPr>
          <a:xfrm>
            <a:off x="3683160" y="8728200"/>
            <a:ext cx="71280" cy="7128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600" bIns="3600" anchor="t">
            <a:norm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Rectangle 354"/>
          <p:cNvSpPr/>
          <p:nvPr/>
        </p:nvSpPr>
        <p:spPr>
          <a:xfrm>
            <a:off x="1479600" y="8701200"/>
            <a:ext cx="73080" cy="73080"/>
          </a:xfrm>
          <a:prstGeom prst="rect">
            <a:avLst/>
          </a:prstGeom>
          <a:solidFill>
            <a:srgbClr val="808080"/>
          </a:solidFill>
          <a:ln w="648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6280" bIns="26280" anchor="t">
            <a:norm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TextBox 10"/>
          <p:cNvSpPr/>
          <p:nvPr/>
        </p:nvSpPr>
        <p:spPr>
          <a:xfrm>
            <a:off x="1515960" y="8561520"/>
            <a:ext cx="1841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GB" sz="1800" spc="-1" strike="noStrike">
                <a:solidFill>
                  <a:srgbClr val="000000"/>
                </a:solidFill>
                <a:latin typeface="Arial"/>
                <a:ea typeface="Arial"/>
              </a:rPr>
              <a:t>LHRH agonist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7" name="Picture 3" descr=""/>
          <p:cNvPicPr/>
          <p:nvPr/>
        </p:nvPicPr>
        <p:blipFill>
          <a:blip r:embed="rId1"/>
          <a:stretch/>
        </p:blipFill>
        <p:spPr>
          <a:xfrm>
            <a:off x="954000" y="1042920"/>
            <a:ext cx="4950000" cy="3600360"/>
          </a:xfrm>
          <a:prstGeom prst="rect">
            <a:avLst/>
          </a:prstGeom>
          <a:ln w="0">
            <a:noFill/>
          </a:ln>
        </p:spPr>
      </p:pic>
      <p:pic>
        <p:nvPicPr>
          <p:cNvPr id="48" name="Picture 4" descr=""/>
          <p:cNvPicPr/>
          <p:nvPr/>
        </p:nvPicPr>
        <p:blipFill>
          <a:blip r:embed="rId2"/>
          <a:stretch/>
        </p:blipFill>
        <p:spPr>
          <a:xfrm>
            <a:off x="954000" y="4846680"/>
            <a:ext cx="4950000" cy="3598920"/>
          </a:xfrm>
          <a:prstGeom prst="rect">
            <a:avLst/>
          </a:prstGeom>
          <a:ln w="0">
            <a:noFill/>
          </a:ln>
        </p:spPr>
      </p:pic>
      <p:sp>
        <p:nvSpPr>
          <p:cNvPr id="49" name="TextBox 2"/>
          <p:cNvSpPr/>
          <p:nvPr/>
        </p:nvSpPr>
        <p:spPr>
          <a:xfrm>
            <a:off x="314280" y="1042920"/>
            <a:ext cx="630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  <a:ea typeface="Arial"/>
              </a:rPr>
              <a:t>(a)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1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11-06T09:23:00Z</dcterms:created>
  <dc:creator>Trinh Duong</dc:creator>
  <dc:description/>
  <dc:language>en-US</dc:language>
  <cp:lastModifiedBy>Jeni Crockett-Holme</cp:lastModifiedBy>
  <cp:lastPrinted>2015-08-13T13:29:18Z</cp:lastPrinted>
  <dcterms:modified xsi:type="dcterms:W3CDTF">2015-11-25T19:32:41Z</dcterms:modified>
  <cp:revision>158</cp:revision>
  <dc:subject/>
  <dc:title>PowerPoint Presentation</dc:title>
</cp:coreProperties>
</file>